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547E7-F833-4DD2-A35B-AEAEE4948D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DFF0F-1DB7-4953-BEBA-3CBE9D27F0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83D573-F57D-4349-93EF-23F05C1481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0C66A-110B-42C2-B8B7-59A2032A95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A9316-F65E-4890-A18D-6EDEFA1447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2965A-9AE8-49C2-A97D-663BBF395A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739E6-DF65-4AA5-8773-0B00936E21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7F98B-A4D5-4C27-9FF5-E1EEAA201E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B5EE0-1FA3-4401-874D-AAD7A4F5CB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3F905-A9F4-4275-8032-F980A8C1BE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D2D27-0851-4D68-8381-C0D4A882F4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BC63F-A70D-49F7-9B6B-75BB7B522C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9D5CB42-CAB4-4765-B6F9-C9F59BBE993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65200" y="5214960"/>
          <a:ext cx="4057560" cy="2997000"/>
        </p:xfrm>
        <a:graphic>
          <a:graphicData uri="http://schemas.openxmlformats.org/drawingml/2006/table">
            <a:tbl>
              <a:tblPr/>
              <a:tblGrid>
                <a:gridCol w="1801800"/>
                <a:gridCol w="1503360"/>
                <a:gridCol w="752400"/>
              </a:tblGrid>
              <a:tr h="377640">
                <a:tc gridSpan="3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TUB1 vs clinicopathological paramet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40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's correlation coeffici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 stat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0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 stat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stological type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mph node metastasis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da-DK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mour st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32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3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Content Placeholder 3" descr=""/>
          <p:cNvPicPr/>
          <p:nvPr/>
        </p:nvPicPr>
        <p:blipFill>
          <a:blip r:embed="rId1"/>
          <a:stretch/>
        </p:blipFill>
        <p:spPr>
          <a:xfrm>
            <a:off x="1455840" y="1190520"/>
            <a:ext cx="3808440" cy="251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44" name="Group 9"/>
          <p:cNvGrpSpPr/>
          <p:nvPr/>
        </p:nvGrpSpPr>
        <p:grpSpPr>
          <a:xfrm>
            <a:off x="3863880" y="1969920"/>
            <a:ext cx="1386000" cy="1729080"/>
            <a:chOff x="3863880" y="1969920"/>
            <a:chExt cx="1386000" cy="1729080"/>
          </a:xfrm>
        </p:grpSpPr>
        <p:pic>
          <p:nvPicPr>
            <p:cNvPr id="45" name="Picture 6" descr=""/>
            <p:cNvPicPr/>
            <p:nvPr/>
          </p:nvPicPr>
          <p:blipFill>
            <a:blip r:embed="rId2"/>
            <a:srcRect l="34324" t="29389" r="28559" b="22720"/>
            <a:stretch/>
          </p:blipFill>
          <p:spPr>
            <a:xfrm>
              <a:off x="3863880" y="1969920"/>
              <a:ext cx="1386000" cy="172908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sp>
          <p:nvSpPr>
            <p:cNvPr id="46" name="Straight Connector 8"/>
            <p:cNvSpPr/>
            <p:nvPr/>
          </p:nvSpPr>
          <p:spPr>
            <a:xfrm>
              <a:off x="4695840" y="3448800"/>
              <a:ext cx="315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7" name="TextBox 10"/>
          <p:cNvSpPr/>
          <p:nvPr/>
        </p:nvSpPr>
        <p:spPr>
          <a:xfrm>
            <a:off x="406800" y="74628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406800" y="492300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1504440" y="752400"/>
            <a:ext cx="373068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egative control for OTUB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4617360" y="3208320"/>
            <a:ext cx="49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μ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21Z</dcterms:modified>
  <cp:revision>924</cp:revision>
  <dc:subject/>
  <dc:title>PowerPoint Presentation</dc:title>
</cp:coreProperties>
</file>